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8" r:id="rId3"/>
    <p:sldId id="275" r:id="rId4"/>
    <p:sldId id="283" r:id="rId5"/>
    <p:sldId id="284" r:id="rId6"/>
    <p:sldId id="279" r:id="rId7"/>
    <p:sldId id="280" r:id="rId8"/>
    <p:sldId id="281" r:id="rId9"/>
    <p:sldId id="282" r:id="rId10"/>
    <p:sldId id="272" r:id="rId11"/>
    <p:sldId id="266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21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2CAC4BE-9B0E-410A-AFCF-278F5F010A77}" v="3" dt="2023-07-14T09:31:14.51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515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2132" y="80"/>
      </p:cViewPr>
      <p:guideLst>
        <p:guide orient="horz" pos="482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eil Halliday" userId="f7d0a42199b8e07e" providerId="LiveId" clId="{C2CAC4BE-9B0E-410A-AFCF-278F5F010A77}"/>
    <pc:docChg chg="undo custSel modSld">
      <pc:chgData name="Neil Halliday" userId="f7d0a42199b8e07e" providerId="LiveId" clId="{C2CAC4BE-9B0E-410A-AFCF-278F5F010A77}" dt="2023-07-14T09:45:47.895" v="186" actId="113"/>
      <pc:docMkLst>
        <pc:docMk/>
      </pc:docMkLst>
      <pc:sldChg chg="modSp mod">
        <pc:chgData name="Neil Halliday" userId="f7d0a42199b8e07e" providerId="LiveId" clId="{C2CAC4BE-9B0E-410A-AFCF-278F5F010A77}" dt="2023-07-14T09:45:47.895" v="186" actId="113"/>
        <pc:sldMkLst>
          <pc:docMk/>
          <pc:sldMk cId="771172679" sldId="279"/>
        </pc:sldMkLst>
        <pc:graphicFrameChg chg="mod modGraphic">
          <ac:chgData name="Neil Halliday" userId="f7d0a42199b8e07e" providerId="LiveId" clId="{C2CAC4BE-9B0E-410A-AFCF-278F5F010A77}" dt="2023-07-14T09:45:47.895" v="186" actId="113"/>
          <ac:graphicFrameMkLst>
            <pc:docMk/>
            <pc:sldMk cId="771172679" sldId="279"/>
            <ac:graphicFrameMk id="5" creationId="{85C9C44B-2AAE-12BD-13B7-6931DC1BC846}"/>
          </ac:graphicFrameMkLst>
        </pc:graphicFrameChg>
      </pc:sldChg>
    </pc:docChg>
  </pc:docChgLst>
  <pc:docChgLst>
    <pc:chgData name="Neil Halliday" userId="f7d0a42199b8e07e" providerId="LiveId" clId="{ABBA4395-4C12-4A5C-A5B8-3643514E7130}"/>
    <pc:docChg chg="undo custSel addSld modSld">
      <pc:chgData name="Neil Halliday" userId="f7d0a42199b8e07e" providerId="LiveId" clId="{ABBA4395-4C12-4A5C-A5B8-3643514E7130}" dt="2023-04-17T10:37:06.479" v="97" actId="20577"/>
      <pc:docMkLst>
        <pc:docMk/>
      </pc:docMkLst>
      <pc:sldChg chg="modSp mod">
        <pc:chgData name="Neil Halliday" userId="f7d0a42199b8e07e" providerId="LiveId" clId="{ABBA4395-4C12-4A5C-A5B8-3643514E7130}" dt="2023-04-17T10:37:06.479" v="97" actId="20577"/>
        <pc:sldMkLst>
          <pc:docMk/>
          <pc:sldMk cId="1904164573" sldId="266"/>
        </pc:sldMkLst>
        <pc:spChg chg="mod">
          <ac:chgData name="Neil Halliday" userId="f7d0a42199b8e07e" providerId="LiveId" clId="{ABBA4395-4C12-4A5C-A5B8-3643514E7130}" dt="2023-04-17T10:37:06.479" v="97" actId="20577"/>
          <ac:spMkLst>
            <pc:docMk/>
            <pc:sldMk cId="1904164573" sldId="266"/>
            <ac:spMk id="3" creationId="{C0E70D5D-4239-097C-23FC-87F5BCE9BDC3}"/>
          </ac:spMkLst>
        </pc:spChg>
      </pc:sldChg>
      <pc:sldChg chg="modSp mod">
        <pc:chgData name="Neil Halliday" userId="f7d0a42199b8e07e" providerId="LiveId" clId="{ABBA4395-4C12-4A5C-A5B8-3643514E7130}" dt="2023-04-17T10:36:53.545" v="93" actId="20577"/>
        <pc:sldMkLst>
          <pc:docMk/>
          <pc:sldMk cId="771172679" sldId="279"/>
        </pc:sldMkLst>
        <pc:spChg chg="mod">
          <ac:chgData name="Neil Halliday" userId="f7d0a42199b8e07e" providerId="LiveId" clId="{ABBA4395-4C12-4A5C-A5B8-3643514E7130}" dt="2023-04-17T10:36:53.545" v="93" actId="20577"/>
          <ac:spMkLst>
            <pc:docMk/>
            <pc:sldMk cId="771172679" sldId="279"/>
            <ac:spMk id="2" creationId="{EFADDCC0-1843-89FA-105F-72B8F70ADA0D}"/>
          </ac:spMkLst>
        </pc:spChg>
      </pc:sldChg>
      <pc:sldChg chg="modSp mod">
        <pc:chgData name="Neil Halliday" userId="f7d0a42199b8e07e" providerId="LiveId" clId="{ABBA4395-4C12-4A5C-A5B8-3643514E7130}" dt="2023-04-17T10:36:56.325" v="94" actId="20577"/>
        <pc:sldMkLst>
          <pc:docMk/>
          <pc:sldMk cId="3107338799" sldId="280"/>
        </pc:sldMkLst>
        <pc:spChg chg="mod">
          <ac:chgData name="Neil Halliday" userId="f7d0a42199b8e07e" providerId="LiveId" clId="{ABBA4395-4C12-4A5C-A5B8-3643514E7130}" dt="2023-04-17T10:36:56.325" v="94" actId="20577"/>
          <ac:spMkLst>
            <pc:docMk/>
            <pc:sldMk cId="3107338799" sldId="280"/>
            <ac:spMk id="4" creationId="{375F4EF8-9479-5FE8-8EEF-3DF38F09141F}"/>
          </ac:spMkLst>
        </pc:spChg>
      </pc:sldChg>
      <pc:sldChg chg="modSp mod">
        <pc:chgData name="Neil Halliday" userId="f7d0a42199b8e07e" providerId="LiveId" clId="{ABBA4395-4C12-4A5C-A5B8-3643514E7130}" dt="2023-04-17T10:36:59.291" v="95" actId="20577"/>
        <pc:sldMkLst>
          <pc:docMk/>
          <pc:sldMk cId="2620669633" sldId="281"/>
        </pc:sldMkLst>
        <pc:spChg chg="mod">
          <ac:chgData name="Neil Halliday" userId="f7d0a42199b8e07e" providerId="LiveId" clId="{ABBA4395-4C12-4A5C-A5B8-3643514E7130}" dt="2023-04-17T10:36:59.291" v="95" actId="20577"/>
          <ac:spMkLst>
            <pc:docMk/>
            <pc:sldMk cId="2620669633" sldId="281"/>
            <ac:spMk id="4" creationId="{DB96AF9A-F9BC-1DF9-4517-588B5E646EA7}"/>
          </ac:spMkLst>
        </pc:spChg>
      </pc:sldChg>
      <pc:sldChg chg="modSp mod">
        <pc:chgData name="Neil Halliday" userId="f7d0a42199b8e07e" providerId="LiveId" clId="{ABBA4395-4C12-4A5C-A5B8-3643514E7130}" dt="2023-04-17T10:37:02.365" v="96" actId="20577"/>
        <pc:sldMkLst>
          <pc:docMk/>
          <pc:sldMk cId="282753509" sldId="282"/>
        </pc:sldMkLst>
        <pc:spChg chg="mod">
          <ac:chgData name="Neil Halliday" userId="f7d0a42199b8e07e" providerId="LiveId" clId="{ABBA4395-4C12-4A5C-A5B8-3643514E7130}" dt="2023-04-17T10:37:02.365" v="96" actId="20577"/>
          <ac:spMkLst>
            <pc:docMk/>
            <pc:sldMk cId="282753509" sldId="282"/>
            <ac:spMk id="4" creationId="{D464D424-1527-F8D6-84C2-0A642E029755}"/>
          </ac:spMkLst>
        </pc:spChg>
      </pc:sldChg>
      <pc:sldChg chg="addSp delSp modSp new mod">
        <pc:chgData name="Neil Halliday" userId="f7d0a42199b8e07e" providerId="LiveId" clId="{ABBA4395-4C12-4A5C-A5B8-3643514E7130}" dt="2023-04-17T10:32:45.009" v="48" actId="14100"/>
        <pc:sldMkLst>
          <pc:docMk/>
          <pc:sldMk cId="31811506" sldId="283"/>
        </pc:sldMkLst>
        <pc:spChg chg="del">
          <ac:chgData name="Neil Halliday" userId="f7d0a42199b8e07e" providerId="LiveId" clId="{ABBA4395-4C12-4A5C-A5B8-3643514E7130}" dt="2023-04-17T10:31:14.600" v="1" actId="478"/>
          <ac:spMkLst>
            <pc:docMk/>
            <pc:sldMk cId="31811506" sldId="283"/>
            <ac:spMk id="2" creationId="{3729C242-111B-ABF1-2498-27B0427B2C42}"/>
          </ac:spMkLst>
        </pc:spChg>
        <pc:spChg chg="del">
          <ac:chgData name="Neil Halliday" userId="f7d0a42199b8e07e" providerId="LiveId" clId="{ABBA4395-4C12-4A5C-A5B8-3643514E7130}" dt="2023-04-17T10:31:17.022" v="2" actId="478"/>
          <ac:spMkLst>
            <pc:docMk/>
            <pc:sldMk cId="31811506" sldId="283"/>
            <ac:spMk id="3" creationId="{CFBFD14C-6083-BF2B-CA0F-C0F2EA92E65E}"/>
          </ac:spMkLst>
        </pc:spChg>
        <pc:spChg chg="add del">
          <ac:chgData name="Neil Halliday" userId="f7d0a42199b8e07e" providerId="LiveId" clId="{ABBA4395-4C12-4A5C-A5B8-3643514E7130}" dt="2023-04-17T10:32:21.053" v="29" actId="22"/>
          <ac:spMkLst>
            <pc:docMk/>
            <pc:sldMk cId="31811506" sldId="283"/>
            <ac:spMk id="7" creationId="{3CC0E252-601C-10FD-605C-1BF5311832B4}"/>
          </ac:spMkLst>
        </pc:spChg>
        <pc:spChg chg="add mod">
          <ac:chgData name="Neil Halliday" userId="f7d0a42199b8e07e" providerId="LiveId" clId="{ABBA4395-4C12-4A5C-A5B8-3643514E7130}" dt="2023-04-17T10:32:45.009" v="48" actId="14100"/>
          <ac:spMkLst>
            <pc:docMk/>
            <pc:sldMk cId="31811506" sldId="283"/>
            <ac:spMk id="9" creationId="{20ABC12B-F9B1-239A-7AAC-286FB8638854}"/>
          </ac:spMkLst>
        </pc:spChg>
        <pc:graphicFrameChg chg="add del mod">
          <ac:chgData name="Neil Halliday" userId="f7d0a42199b8e07e" providerId="LiveId" clId="{ABBA4395-4C12-4A5C-A5B8-3643514E7130}" dt="2023-04-17T10:31:25.006" v="10"/>
          <ac:graphicFrameMkLst>
            <pc:docMk/>
            <pc:sldMk cId="31811506" sldId="283"/>
            <ac:graphicFrameMk id="4" creationId="{4EDE0958-3416-9661-C9D4-8E4829D6AEC5}"/>
          </ac:graphicFrameMkLst>
        </pc:graphicFrameChg>
        <pc:graphicFrameChg chg="add mod modGraphic">
          <ac:chgData name="Neil Halliday" userId="f7d0a42199b8e07e" providerId="LiveId" clId="{ABBA4395-4C12-4A5C-A5B8-3643514E7130}" dt="2023-04-17T10:32:01.600" v="27"/>
          <ac:graphicFrameMkLst>
            <pc:docMk/>
            <pc:sldMk cId="31811506" sldId="283"/>
            <ac:graphicFrameMk id="5" creationId="{F42FDCEB-9EDC-D83B-01B9-88E95265F810}"/>
          </ac:graphicFrameMkLst>
        </pc:graphicFrameChg>
      </pc:sldChg>
      <pc:sldChg chg="addSp delSp modSp new mod">
        <pc:chgData name="Neil Halliday" userId="f7d0a42199b8e07e" providerId="LiveId" clId="{ABBA4395-4C12-4A5C-A5B8-3643514E7130}" dt="2023-04-17T10:36:40.606" v="92" actId="20577"/>
        <pc:sldMkLst>
          <pc:docMk/>
          <pc:sldMk cId="488753592" sldId="284"/>
        </pc:sldMkLst>
        <pc:spChg chg="del">
          <ac:chgData name="Neil Halliday" userId="f7d0a42199b8e07e" providerId="LiveId" clId="{ABBA4395-4C12-4A5C-A5B8-3643514E7130}" dt="2023-04-17T10:35:51.569" v="59" actId="478"/>
          <ac:spMkLst>
            <pc:docMk/>
            <pc:sldMk cId="488753592" sldId="284"/>
            <ac:spMk id="3" creationId="{D8410845-3BCC-C07A-C478-4308446B3D04}"/>
          </ac:spMkLst>
        </pc:spChg>
        <pc:spChg chg="add mod">
          <ac:chgData name="Neil Halliday" userId="f7d0a42199b8e07e" providerId="LiveId" clId="{ABBA4395-4C12-4A5C-A5B8-3643514E7130}" dt="2023-04-17T10:36:40.606" v="92" actId="20577"/>
          <ac:spMkLst>
            <pc:docMk/>
            <pc:sldMk cId="488753592" sldId="284"/>
            <ac:spMk id="7" creationId="{AB252753-33AA-B10B-5F40-EC3D10A4CA8B}"/>
          </ac:spMkLst>
        </pc:spChg>
        <pc:graphicFrameChg chg="add del mod">
          <ac:chgData name="Neil Halliday" userId="f7d0a42199b8e07e" providerId="LiveId" clId="{ABBA4395-4C12-4A5C-A5B8-3643514E7130}" dt="2023-04-17T10:36:04.351" v="63"/>
          <ac:graphicFrameMkLst>
            <pc:docMk/>
            <pc:sldMk cId="488753592" sldId="284"/>
            <ac:graphicFrameMk id="4" creationId="{0878AF8C-748F-A49B-5A96-4BA2EEE5A070}"/>
          </ac:graphicFrameMkLst>
        </pc:graphicFrameChg>
        <pc:graphicFrameChg chg="add mod">
          <ac:chgData name="Neil Halliday" userId="f7d0a42199b8e07e" providerId="LiveId" clId="{ABBA4395-4C12-4A5C-A5B8-3643514E7130}" dt="2023-04-17T10:36:04.561" v="64"/>
          <ac:graphicFrameMkLst>
            <pc:docMk/>
            <pc:sldMk cId="488753592" sldId="284"/>
            <ac:graphicFrameMk id="5" creationId="{49EFFBA3-564D-0E29-3135-DBA785E63C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631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9642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3914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808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997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3298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0079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536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8692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5047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4898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2019E5-F9D4-4A20-A881-868AE436F76C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7F3F2-5B6E-4F4C-97F0-0173624067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9042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0F58144-D0EB-6527-FE42-F7983DA6D4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21878945"/>
              </p:ext>
            </p:extLst>
          </p:nvPr>
        </p:nvGraphicFramePr>
        <p:xfrm>
          <a:off x="563561" y="2365908"/>
          <a:ext cx="5973762" cy="45738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3901320" imgH="2986920" progId="Origin95.Graph">
                  <p:embed/>
                </p:oleObj>
              </mc:Choice>
              <mc:Fallback>
                <p:oleObj name="Graph" r:id="rId2" imgW="3901320" imgH="2986920" progId="Origin95.Graph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B0F58144-D0EB-6527-FE42-F7983DA6D4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63561" y="2365908"/>
                        <a:ext cx="5973762" cy="45738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E72A935-D0D1-0AAF-B46E-8120A40EC6E6}"/>
              </a:ext>
            </a:extLst>
          </p:cNvPr>
          <p:cNvSpPr txBox="1"/>
          <p:nvPr/>
        </p:nvSpPr>
        <p:spPr>
          <a:xfrm>
            <a:off x="457200" y="6901807"/>
            <a:ext cx="59293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figure 1: Histogram of age of onset of CVID in those with and without liver disease</a:t>
            </a:r>
            <a:endParaRPr lang="en-GB" sz="1400" dirty="0">
              <a:effectLst/>
              <a:latin typeface="Calibri 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65473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152F11F-257B-D75A-5614-8C255C4E6AB0}"/>
              </a:ext>
            </a:extLst>
          </p:cNvPr>
          <p:cNvSpPr txBox="1"/>
          <p:nvPr/>
        </p:nvSpPr>
        <p:spPr>
          <a:xfrm>
            <a:off x="1735062" y="6175857"/>
            <a:ext cx="3461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GB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7975DDA-B21A-C669-E583-0A3592DD29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6309366"/>
              </p:ext>
            </p:extLst>
          </p:nvPr>
        </p:nvGraphicFramePr>
        <p:xfrm>
          <a:off x="1912029" y="1257425"/>
          <a:ext cx="3033941" cy="23215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Graph" r:id="rId2" imgW="3920760" imgH="3000960" progId="Origin95.Graph">
                  <p:embed/>
                </p:oleObj>
              </mc:Choice>
              <mc:Fallback>
                <p:oleObj name="Graph" r:id="rId2" imgW="3920760" imgH="3000960" progId="Origin95.Graph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7975DDA-B21A-C669-E583-0A3592DD29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12029" y="1257425"/>
                        <a:ext cx="3033941" cy="23215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Picture 6">
            <a:extLst>
              <a:ext uri="{FF2B5EF4-FFF2-40B4-BE49-F238E27FC236}">
                <a16:creationId xmlns:a16="http://schemas.microsoft.com/office/drawing/2014/main" id="{65E69866-509A-0CA4-C602-B54821E808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3590" y="3578943"/>
            <a:ext cx="4250820" cy="250663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F0B32B5-E6FB-EAE4-8E51-7CBD65110ACC}"/>
              </a:ext>
            </a:extLst>
          </p:cNvPr>
          <p:cNvSpPr txBox="1"/>
          <p:nvPr/>
        </p:nvSpPr>
        <p:spPr>
          <a:xfrm>
            <a:off x="497750" y="7336871"/>
            <a:ext cx="58625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figure 3: A – Hepatic venous pressure gradient (HVPG) measurements and evidence of portal hypertension by endoscopic or radiological assessment in patients with CVID-related liver disease (line represents median value). B –receiver operator curve and area under receiver operator curve (AUROC) characteristics for HVPG as a predictor of endoscopic or radiological evidence of portal hypertension. </a:t>
            </a:r>
          </a:p>
        </p:txBody>
      </p:sp>
      <p:graphicFrame>
        <p:nvGraphicFramePr>
          <p:cNvPr id="10" name="Table 3">
            <a:extLst>
              <a:ext uri="{FF2B5EF4-FFF2-40B4-BE49-F238E27FC236}">
                <a16:creationId xmlns:a16="http://schemas.microsoft.com/office/drawing/2014/main" id="{870AE2F4-6707-A84E-1959-21CD4B1B65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8796097"/>
              </p:ext>
            </p:extLst>
          </p:nvPr>
        </p:nvGraphicFramePr>
        <p:xfrm>
          <a:off x="1396950" y="6105201"/>
          <a:ext cx="4064101" cy="6977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57744">
                  <a:extLst>
                    <a:ext uri="{9D8B030D-6E8A-4147-A177-3AD203B41FA5}">
                      <a16:colId xmlns:a16="http://schemas.microsoft.com/office/drawing/2014/main" val="1145586952"/>
                    </a:ext>
                  </a:extLst>
                </a:gridCol>
                <a:gridCol w="602119">
                  <a:extLst>
                    <a:ext uri="{9D8B030D-6E8A-4147-A177-3AD203B41FA5}">
                      <a16:colId xmlns:a16="http://schemas.microsoft.com/office/drawing/2014/main" val="3815422867"/>
                    </a:ext>
                  </a:extLst>
                </a:gridCol>
                <a:gridCol w="602119">
                  <a:extLst>
                    <a:ext uri="{9D8B030D-6E8A-4147-A177-3AD203B41FA5}">
                      <a16:colId xmlns:a16="http://schemas.microsoft.com/office/drawing/2014/main" val="4273680327"/>
                    </a:ext>
                  </a:extLst>
                </a:gridCol>
                <a:gridCol w="602119">
                  <a:extLst>
                    <a:ext uri="{9D8B030D-6E8A-4147-A177-3AD203B41FA5}">
                      <a16:colId xmlns:a16="http://schemas.microsoft.com/office/drawing/2014/main" val="1204670409"/>
                    </a:ext>
                  </a:extLst>
                </a:gridCol>
              </a:tblGrid>
              <a:tr h="181415">
                <a:tc>
                  <a:txBody>
                    <a:bodyPr/>
                    <a:lstStyle/>
                    <a:p>
                      <a:pPr algn="ctr"/>
                      <a:endParaRPr lang="en-GB" sz="8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solidFill>
                            <a:schemeClr val="tx1"/>
                          </a:solidFill>
                        </a:rPr>
                        <a:t>AUROC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lang="en-GB" sz="1000" dirty="0"/>
                        <a:t>AUROC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3516255"/>
                  </a:ext>
                </a:extLst>
              </a:tr>
              <a:tr h="181415"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solidFill>
                            <a:schemeClr val="tx1"/>
                          </a:solidFill>
                        </a:rPr>
                        <a:t>Measure of portal hypertension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solidFill>
                            <a:schemeClr val="tx1"/>
                          </a:solidFill>
                        </a:rPr>
                        <a:t>Area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solidFill>
                            <a:schemeClr val="tx1"/>
                          </a:solidFill>
                        </a:rPr>
                        <a:t>95% CI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>
                          <a:solidFill>
                            <a:schemeClr val="tx1"/>
                          </a:solidFill>
                        </a:rPr>
                        <a:t>p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1296781"/>
                  </a:ext>
                </a:extLst>
              </a:tr>
              <a:tr h="271013"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Endoscopic / radiological evidence</a:t>
                      </a:r>
                    </a:p>
                  </a:txBody>
                  <a:tcPr anchor="ctr"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0.57</a:t>
                      </a:r>
                    </a:p>
                  </a:txBody>
                  <a:tcPr anchor="ctr"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0.38-0.77</a:t>
                      </a:r>
                    </a:p>
                  </a:txBody>
                  <a:tcPr anchor="ctr"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/>
                        <a:t>0.45</a:t>
                      </a:r>
                    </a:p>
                  </a:txBody>
                  <a:tcPr anchor="ctr"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7761989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4C64C002-A0FD-3C23-CE67-1ED40F2DBC3A}"/>
              </a:ext>
            </a:extLst>
          </p:cNvPr>
          <p:cNvSpPr/>
          <p:nvPr/>
        </p:nvSpPr>
        <p:spPr>
          <a:xfrm>
            <a:off x="1543485" y="3756618"/>
            <a:ext cx="3685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8D16F32-9077-8199-449D-82B7A53A1627}"/>
              </a:ext>
            </a:extLst>
          </p:cNvPr>
          <p:cNvSpPr/>
          <p:nvPr/>
        </p:nvSpPr>
        <p:spPr>
          <a:xfrm>
            <a:off x="1558328" y="1435100"/>
            <a:ext cx="36854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0051138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8051840-6ACE-C31B-7282-7AB803C334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1379772"/>
              </p:ext>
            </p:extLst>
          </p:nvPr>
        </p:nvGraphicFramePr>
        <p:xfrm>
          <a:off x="471488" y="2359025"/>
          <a:ext cx="5915025" cy="446162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35196">
                  <a:extLst>
                    <a:ext uri="{9D8B030D-6E8A-4147-A177-3AD203B41FA5}">
                      <a16:colId xmlns:a16="http://schemas.microsoft.com/office/drawing/2014/main" val="3444056306"/>
                    </a:ext>
                  </a:extLst>
                </a:gridCol>
                <a:gridCol w="1200402">
                  <a:extLst>
                    <a:ext uri="{9D8B030D-6E8A-4147-A177-3AD203B41FA5}">
                      <a16:colId xmlns:a16="http://schemas.microsoft.com/office/drawing/2014/main" val="3127026727"/>
                    </a:ext>
                  </a:extLst>
                </a:gridCol>
                <a:gridCol w="426230">
                  <a:extLst>
                    <a:ext uri="{9D8B030D-6E8A-4147-A177-3AD203B41FA5}">
                      <a16:colId xmlns:a16="http://schemas.microsoft.com/office/drawing/2014/main" val="1601614864"/>
                    </a:ext>
                  </a:extLst>
                </a:gridCol>
                <a:gridCol w="426230">
                  <a:extLst>
                    <a:ext uri="{9D8B030D-6E8A-4147-A177-3AD203B41FA5}">
                      <a16:colId xmlns:a16="http://schemas.microsoft.com/office/drawing/2014/main" val="2862615647"/>
                    </a:ext>
                  </a:extLst>
                </a:gridCol>
                <a:gridCol w="452325">
                  <a:extLst>
                    <a:ext uri="{9D8B030D-6E8A-4147-A177-3AD203B41FA5}">
                      <a16:colId xmlns:a16="http://schemas.microsoft.com/office/drawing/2014/main" val="3527148631"/>
                    </a:ext>
                  </a:extLst>
                </a:gridCol>
                <a:gridCol w="426230">
                  <a:extLst>
                    <a:ext uri="{9D8B030D-6E8A-4147-A177-3AD203B41FA5}">
                      <a16:colId xmlns:a16="http://schemas.microsoft.com/office/drawing/2014/main" val="4106664823"/>
                    </a:ext>
                  </a:extLst>
                </a:gridCol>
                <a:gridCol w="426230">
                  <a:extLst>
                    <a:ext uri="{9D8B030D-6E8A-4147-A177-3AD203B41FA5}">
                      <a16:colId xmlns:a16="http://schemas.microsoft.com/office/drawing/2014/main" val="4056314572"/>
                    </a:ext>
                  </a:extLst>
                </a:gridCol>
                <a:gridCol w="426230">
                  <a:extLst>
                    <a:ext uri="{9D8B030D-6E8A-4147-A177-3AD203B41FA5}">
                      <a16:colId xmlns:a16="http://schemas.microsoft.com/office/drawing/2014/main" val="3760600044"/>
                    </a:ext>
                  </a:extLst>
                </a:gridCol>
                <a:gridCol w="478421">
                  <a:extLst>
                    <a:ext uri="{9D8B030D-6E8A-4147-A177-3AD203B41FA5}">
                      <a16:colId xmlns:a16="http://schemas.microsoft.com/office/drawing/2014/main" val="2941677298"/>
                    </a:ext>
                  </a:extLst>
                </a:gridCol>
                <a:gridCol w="417531">
                  <a:extLst>
                    <a:ext uri="{9D8B030D-6E8A-4147-A177-3AD203B41FA5}">
                      <a16:colId xmlns:a16="http://schemas.microsoft.com/office/drawing/2014/main" val="1591777372"/>
                    </a:ext>
                  </a:extLst>
                </a:gridCol>
              </a:tblGrid>
              <a:tr h="126129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Univariat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Multivariat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1172827"/>
                  </a:ext>
                </a:extLst>
              </a:tr>
              <a:tr h="130478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H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95% C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p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H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95% C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p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387411121"/>
                  </a:ext>
                </a:extLst>
              </a:tr>
              <a:tr h="130478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t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Low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Upp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Low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</a:rPr>
                        <a:t>Upp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3512737"/>
                  </a:ext>
                </a:extLst>
              </a:tr>
              <a:tr h="130478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2788362010"/>
                  </a:ext>
                </a:extLst>
              </a:tr>
              <a:tr h="130478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ale Gender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56994742"/>
                  </a:ext>
                </a:extLst>
              </a:tr>
              <a:tr h="130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ge at CVID diagnosis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years)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5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2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7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&lt;0.001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6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3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09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&lt;0.001</a:t>
                      </a: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4274763737"/>
                  </a:ext>
                </a:extLst>
              </a:tr>
              <a:tr h="130478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ra of diagnosis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‘80-’99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7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1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9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305278158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‘00-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939177295"/>
                  </a:ext>
                </a:extLst>
              </a:tr>
              <a:tr h="130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iver disease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82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33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01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7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2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8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0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61171634"/>
                  </a:ext>
                </a:extLst>
              </a:tr>
              <a:tr h="130478">
                <a:tc rowSpan="3"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ung disease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y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125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9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.96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3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530112889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nterstitial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62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27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42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1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09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52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9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</a:t>
                      </a: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264078446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ronchiectasi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9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5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2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904712441"/>
                  </a:ext>
                </a:extLst>
              </a:tr>
              <a:tr h="130478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plenomegal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&gt;12.5c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18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2876951062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plenectom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1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.06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2183829602"/>
                  </a:ext>
                </a:extLst>
              </a:tr>
              <a:tr h="13047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ersistent lymphadenopath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t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07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2232811000"/>
                  </a:ext>
                </a:extLst>
              </a:tr>
              <a:tr h="130478">
                <a:tc rowSpan="5"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astrointestinal diseas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8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7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2543098552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hronic diarrhoe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7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148772721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n-infective enteropathy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2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55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822371683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nflammatory bowel diseas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65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5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006152903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nfective diarrhoe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7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388585412"/>
                  </a:ext>
                </a:extLst>
              </a:tr>
              <a:tr h="147706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GB" sz="800" b="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heumatological involvemen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rthralgi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2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7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939264357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800" b="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nflammatory arthriti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81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3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4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4213087480"/>
                  </a:ext>
                </a:extLst>
              </a:tr>
              <a:tr h="130478">
                <a:tc rowSpan="4"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ytopaeni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5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0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0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32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969021845"/>
                  </a:ext>
                </a:extLst>
              </a:tr>
              <a:tr h="32620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TP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2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071412681"/>
                  </a:ext>
                </a:extLst>
              </a:tr>
              <a:tr h="65239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IH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25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2494862841"/>
                  </a:ext>
                </a:extLst>
              </a:tr>
              <a:tr h="139361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I </a:t>
                      </a:r>
                      <a:r>
                        <a:rPr lang="en-GB" sz="800" u="none" strike="noStrike" dirty="0" err="1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eutropaenia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43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603599465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GB" sz="8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hyroid disease</a:t>
                      </a:r>
                      <a:endParaRPr lang="en-GB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.21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762143887"/>
                  </a:ext>
                </a:extLst>
              </a:tr>
              <a:tr h="146573">
                <a:tc rowSpan="7"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xposure to immunosuppression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8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.9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183289490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orticosteroids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08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00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3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28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41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4286526364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ycophenolate mofeti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9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.48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8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88527305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ituximab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4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.01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144498710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zathioprin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6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.0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3794491776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iclospori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.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0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.44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6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1277330352"/>
                  </a:ext>
                </a:extLst>
              </a:tr>
              <a:tr h="130478">
                <a:tc vMerge="1"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u="none" strike="noStrike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ti-TN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49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86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.22</a:t>
                      </a: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0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4349" marR="4349" marT="4349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7</a:t>
                      </a:r>
                    </a:p>
                  </a:txBody>
                  <a:tcPr marL="4349" marR="4349" marT="434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</a:t>
                      </a:r>
                    </a:p>
                  </a:txBody>
                  <a:tcPr marL="4349" marR="4349" marT="4349" marB="0" anchor="b"/>
                </a:tc>
                <a:extLst>
                  <a:ext uri="{0D108BD9-81ED-4DB2-BD59-A6C34878D82A}">
                    <a16:rowId xmlns:a16="http://schemas.microsoft.com/office/drawing/2014/main" val="7925911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C0E70D5D-4239-097C-23FC-87F5BCE9BDC3}"/>
              </a:ext>
            </a:extLst>
          </p:cNvPr>
          <p:cNvSpPr txBox="1"/>
          <p:nvPr/>
        </p:nvSpPr>
        <p:spPr>
          <a:xfrm>
            <a:off x="471488" y="6851978"/>
            <a:ext cx="59150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</a:t>
            </a:r>
            <a:r>
              <a:rPr lang="en-US" sz="1400"/>
              <a:t>table 8: </a:t>
            </a:r>
            <a:r>
              <a:rPr lang="en-US" sz="1400" dirty="0"/>
              <a:t>Cox-proportional hazard models for the risk of death in the population of CVID patients excluding those diagnosed in the 1960s and 1970s</a:t>
            </a:r>
          </a:p>
        </p:txBody>
      </p:sp>
    </p:spTree>
    <p:extLst>
      <p:ext uri="{BB962C8B-B14F-4D97-AF65-F5344CB8AC3E}">
        <p14:creationId xmlns:p14="http://schemas.microsoft.com/office/powerpoint/2010/main" val="1904164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388CF936-9EC9-0B02-6BD8-F3065FCC6A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186" y="1874827"/>
            <a:ext cx="6488115" cy="496994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D9079A5-B7D8-D759-5A4F-1A5224535877}"/>
              </a:ext>
            </a:extLst>
          </p:cNvPr>
          <p:cNvSpPr txBox="1"/>
          <p:nvPr/>
        </p:nvSpPr>
        <p:spPr>
          <a:xfrm>
            <a:off x="464343" y="6783274"/>
            <a:ext cx="59293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figure 2: Duration of follow up of those with and without liver disease</a:t>
            </a:r>
            <a:endParaRPr lang="en-GB" sz="1400" dirty="0">
              <a:effectLst/>
              <a:latin typeface="Calibri 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43840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41E890D6-20F7-AC55-62AE-93BB1D91749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62490983"/>
              </p:ext>
            </p:extLst>
          </p:nvPr>
        </p:nvGraphicFramePr>
        <p:xfrm>
          <a:off x="628650" y="4359434"/>
          <a:ext cx="5354781" cy="25514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6825">
                  <a:extLst>
                    <a:ext uri="{9D8B030D-6E8A-4147-A177-3AD203B41FA5}">
                      <a16:colId xmlns:a16="http://schemas.microsoft.com/office/drawing/2014/main" val="101142466"/>
                    </a:ext>
                  </a:extLst>
                </a:gridCol>
                <a:gridCol w="742950">
                  <a:extLst>
                    <a:ext uri="{9D8B030D-6E8A-4147-A177-3AD203B41FA5}">
                      <a16:colId xmlns:a16="http://schemas.microsoft.com/office/drawing/2014/main" val="2418083727"/>
                    </a:ext>
                  </a:extLst>
                </a:gridCol>
                <a:gridCol w="557501">
                  <a:extLst>
                    <a:ext uri="{9D8B030D-6E8A-4147-A177-3AD203B41FA5}">
                      <a16:colId xmlns:a16="http://schemas.microsoft.com/office/drawing/2014/main" val="1939983608"/>
                    </a:ext>
                  </a:extLst>
                </a:gridCol>
                <a:gridCol w="557501">
                  <a:extLst>
                    <a:ext uri="{9D8B030D-6E8A-4147-A177-3AD203B41FA5}">
                      <a16:colId xmlns:a16="http://schemas.microsoft.com/office/drawing/2014/main" val="195902480"/>
                    </a:ext>
                  </a:extLst>
                </a:gridCol>
                <a:gridCol w="557501">
                  <a:extLst>
                    <a:ext uri="{9D8B030D-6E8A-4147-A177-3AD203B41FA5}">
                      <a16:colId xmlns:a16="http://schemas.microsoft.com/office/drawing/2014/main" val="2113293829"/>
                    </a:ext>
                  </a:extLst>
                </a:gridCol>
                <a:gridCol w="557501">
                  <a:extLst>
                    <a:ext uri="{9D8B030D-6E8A-4147-A177-3AD203B41FA5}">
                      <a16:colId xmlns:a16="http://schemas.microsoft.com/office/drawing/2014/main" val="1877996692"/>
                    </a:ext>
                  </a:extLst>
                </a:gridCol>
                <a:gridCol w="557501">
                  <a:extLst>
                    <a:ext uri="{9D8B030D-6E8A-4147-A177-3AD203B41FA5}">
                      <a16:colId xmlns:a16="http://schemas.microsoft.com/office/drawing/2014/main" val="954604391"/>
                    </a:ext>
                  </a:extLst>
                </a:gridCol>
                <a:gridCol w="557501">
                  <a:extLst>
                    <a:ext uri="{9D8B030D-6E8A-4147-A177-3AD203B41FA5}">
                      <a16:colId xmlns:a16="http://schemas.microsoft.com/office/drawing/2014/main" val="720779565"/>
                    </a:ext>
                  </a:extLst>
                </a:gridCol>
              </a:tblGrid>
              <a:tr h="184150">
                <a:tc rowSpan="2" gridSpan="2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rowSpan="2"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Liver Disease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o liver disease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Total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31942220"/>
                  </a:ext>
                </a:extLst>
              </a:tr>
              <a:tr h="184150">
                <a:tc gridSpan="2" v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 v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effectLst/>
                        </a:rPr>
                        <a:t>n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>
                          <a:effectLst/>
                        </a:rPr>
                        <a:t>%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n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27315308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Tota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9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1.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2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58.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1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71067471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CT scan of thorax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9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0.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1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91.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0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95.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08678495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Abdominal imaging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USS, CT, MRI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9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90.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07045230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Upper GI endosocop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8.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7.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8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8.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82148087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Video Capsule Endoscop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7.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.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5.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742976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Lower GI endoscop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8.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8.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7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2.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06215275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>
                          <a:effectLst/>
                        </a:rPr>
                        <a:t>Small bowel histolog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7.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1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8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8.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18295404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Fibrosca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4.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.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9.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62698993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HVPG measuremen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0.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6.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00505938"/>
                  </a:ext>
                </a:extLst>
              </a:tr>
              <a:tr h="18415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</a:rPr>
                        <a:t>Liver biops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8.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67926087"/>
                  </a:ext>
                </a:extLst>
              </a:tr>
              <a:tr h="184150">
                <a:tc gridSpan="8"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: computed tomography, USS: ultrasound scan, MRI: magnetic resonance imaging, GI: gastrointestinal, HVPG: hepatic venous pressure gradient</a:t>
                      </a: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184714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E0F7F76-8B5F-3E47-2CD7-9B8CF404B929}"/>
              </a:ext>
            </a:extLst>
          </p:cNvPr>
          <p:cNvSpPr txBox="1"/>
          <p:nvPr/>
        </p:nvSpPr>
        <p:spPr>
          <a:xfrm>
            <a:off x="628650" y="6910864"/>
            <a:ext cx="5929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table 1: Examinations performed in patient cohort</a:t>
            </a:r>
            <a:endParaRPr lang="en-GB" sz="1400" dirty="0">
              <a:effectLst/>
              <a:latin typeface="Calibri 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77075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42FDCEB-9EDC-D83B-01B9-88E95265F8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3818021"/>
              </p:ext>
            </p:extLst>
          </p:nvPr>
        </p:nvGraphicFramePr>
        <p:xfrm>
          <a:off x="506729" y="3970494"/>
          <a:ext cx="4963565" cy="3617600"/>
        </p:xfrm>
        <a:graphic>
          <a:graphicData uri="http://schemas.openxmlformats.org/drawingml/2006/table">
            <a:tbl>
              <a:tblPr firstRow="1" bandRow="1"/>
              <a:tblGrid>
                <a:gridCol w="1020328">
                  <a:extLst>
                    <a:ext uri="{9D8B030D-6E8A-4147-A177-3AD203B41FA5}">
                      <a16:colId xmlns:a16="http://schemas.microsoft.com/office/drawing/2014/main" val="824523708"/>
                    </a:ext>
                  </a:extLst>
                </a:gridCol>
                <a:gridCol w="512489">
                  <a:extLst>
                    <a:ext uri="{9D8B030D-6E8A-4147-A177-3AD203B41FA5}">
                      <a16:colId xmlns:a16="http://schemas.microsoft.com/office/drawing/2014/main" val="3471772211"/>
                    </a:ext>
                  </a:extLst>
                </a:gridCol>
                <a:gridCol w="512489">
                  <a:extLst>
                    <a:ext uri="{9D8B030D-6E8A-4147-A177-3AD203B41FA5}">
                      <a16:colId xmlns:a16="http://schemas.microsoft.com/office/drawing/2014/main" val="2107458747"/>
                    </a:ext>
                  </a:extLst>
                </a:gridCol>
                <a:gridCol w="72000">
                  <a:extLst>
                    <a:ext uri="{9D8B030D-6E8A-4147-A177-3AD203B41FA5}">
                      <a16:colId xmlns:a16="http://schemas.microsoft.com/office/drawing/2014/main" val="1463040231"/>
                    </a:ext>
                  </a:extLst>
                </a:gridCol>
                <a:gridCol w="512489">
                  <a:extLst>
                    <a:ext uri="{9D8B030D-6E8A-4147-A177-3AD203B41FA5}">
                      <a16:colId xmlns:a16="http://schemas.microsoft.com/office/drawing/2014/main" val="2202350565"/>
                    </a:ext>
                  </a:extLst>
                </a:gridCol>
                <a:gridCol w="512489">
                  <a:extLst>
                    <a:ext uri="{9D8B030D-6E8A-4147-A177-3AD203B41FA5}">
                      <a16:colId xmlns:a16="http://schemas.microsoft.com/office/drawing/2014/main" val="312873475"/>
                    </a:ext>
                  </a:extLst>
                </a:gridCol>
                <a:gridCol w="72000">
                  <a:extLst>
                    <a:ext uri="{9D8B030D-6E8A-4147-A177-3AD203B41FA5}">
                      <a16:colId xmlns:a16="http://schemas.microsoft.com/office/drawing/2014/main" val="945893624"/>
                    </a:ext>
                  </a:extLst>
                </a:gridCol>
                <a:gridCol w="512489">
                  <a:extLst>
                    <a:ext uri="{9D8B030D-6E8A-4147-A177-3AD203B41FA5}">
                      <a16:colId xmlns:a16="http://schemas.microsoft.com/office/drawing/2014/main" val="327301052"/>
                    </a:ext>
                  </a:extLst>
                </a:gridCol>
                <a:gridCol w="618396">
                  <a:extLst>
                    <a:ext uri="{9D8B030D-6E8A-4147-A177-3AD203B41FA5}">
                      <a16:colId xmlns:a16="http://schemas.microsoft.com/office/drawing/2014/main" val="1662606693"/>
                    </a:ext>
                  </a:extLst>
                </a:gridCol>
                <a:gridCol w="618396">
                  <a:extLst>
                    <a:ext uri="{9D8B030D-6E8A-4147-A177-3AD203B41FA5}">
                      <a16:colId xmlns:a16="http://schemas.microsoft.com/office/drawing/2014/main" val="170466583"/>
                    </a:ext>
                  </a:extLst>
                </a:gridCol>
              </a:tblGrid>
              <a:tr h="201930">
                <a:tc row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mmunosuppression exposur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iver Diseas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 liver diseas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9472216"/>
                  </a:ext>
                </a:extLst>
              </a:tr>
              <a:tr h="25336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4356410"/>
                  </a:ext>
                </a:extLst>
              </a:tr>
              <a:tr h="25844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3.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4.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8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1995102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rticosteroid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9.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3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5.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3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8545747"/>
                  </a:ext>
                </a:extLst>
              </a:tr>
              <a:tr h="31432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ycophenolate mofetil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5607186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ituximab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.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5279287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zathioprin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4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1629552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iclospori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7721041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ti-TNF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3348492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irolimu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215881"/>
                  </a:ext>
                </a:extLst>
              </a:tr>
              <a:tr h="25336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th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4914356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20ABC12B-F9B1-239A-7AAC-286FB8638854}"/>
              </a:ext>
            </a:extLst>
          </p:cNvPr>
          <p:cNvSpPr txBox="1"/>
          <p:nvPr/>
        </p:nvSpPr>
        <p:spPr>
          <a:xfrm>
            <a:off x="414020" y="7588094"/>
            <a:ext cx="505627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/>
              <a:t>Supplementary Table 2: Immunosuppressive treatments received by CVID patients with and without liver disease</a:t>
            </a:r>
          </a:p>
        </p:txBody>
      </p:sp>
    </p:spTree>
    <p:extLst>
      <p:ext uri="{BB962C8B-B14F-4D97-AF65-F5344CB8AC3E}">
        <p14:creationId xmlns:p14="http://schemas.microsoft.com/office/powerpoint/2010/main" val="318115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95692B-94C3-B7AF-86CA-5DBFFB19D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9EFFBA3-564D-0E29-3135-DBA785E63CF0}"/>
              </a:ext>
            </a:extLst>
          </p:cNvPr>
          <p:cNvGraphicFramePr>
            <a:graphicFrameLocks noGrp="1"/>
          </p:cNvGraphicFramePr>
          <p:nvPr/>
        </p:nvGraphicFramePr>
        <p:xfrm>
          <a:off x="1143000" y="4011070"/>
          <a:ext cx="4572001" cy="3536448"/>
        </p:xfrm>
        <a:graphic>
          <a:graphicData uri="http://schemas.openxmlformats.org/drawingml/2006/table">
            <a:tbl>
              <a:tblPr firstRow="1" bandRow="1"/>
              <a:tblGrid>
                <a:gridCol w="1347950">
                  <a:extLst>
                    <a:ext uri="{9D8B030D-6E8A-4147-A177-3AD203B41FA5}">
                      <a16:colId xmlns:a16="http://schemas.microsoft.com/office/drawing/2014/main" val="1197777978"/>
                    </a:ext>
                  </a:extLst>
                </a:gridCol>
                <a:gridCol w="1134781">
                  <a:extLst>
                    <a:ext uri="{9D8B030D-6E8A-4147-A177-3AD203B41FA5}">
                      <a16:colId xmlns:a16="http://schemas.microsoft.com/office/drawing/2014/main" val="2607441253"/>
                    </a:ext>
                  </a:extLst>
                </a:gridCol>
                <a:gridCol w="1134781">
                  <a:extLst>
                    <a:ext uri="{9D8B030D-6E8A-4147-A177-3AD203B41FA5}">
                      <a16:colId xmlns:a16="http://schemas.microsoft.com/office/drawing/2014/main" val="3762047880"/>
                    </a:ext>
                  </a:extLst>
                </a:gridCol>
                <a:gridCol w="954489">
                  <a:extLst>
                    <a:ext uri="{9D8B030D-6E8A-4147-A177-3AD203B41FA5}">
                      <a16:colId xmlns:a16="http://schemas.microsoft.com/office/drawing/2014/main" val="1248967521"/>
                    </a:ext>
                  </a:extLst>
                </a:gridCol>
              </a:tblGrid>
              <a:tr h="198120">
                <a:tc grid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stological featur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A5A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9691266"/>
                  </a:ext>
                </a:extLst>
              </a:tr>
              <a:tr h="198120">
                <a:tc grid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dular Regenerative Hyperplasi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3.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6104264"/>
                  </a:ext>
                </a:extLst>
              </a:tr>
              <a:tr h="198120">
                <a:tc grid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ranulomat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9471831"/>
                  </a:ext>
                </a:extLst>
              </a:tr>
              <a:tr h="198120">
                <a:tc rowSpan="6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ibrosis stag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* n=43 where fibrosis stage could be assesse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7*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8658929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.9*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5990684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0.2*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9943760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6.5*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5373021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7*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7255518"/>
                  </a:ext>
                </a:extLst>
              </a:tr>
              <a:tr h="1981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nabl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388127"/>
                  </a:ext>
                </a:extLst>
              </a:tr>
              <a:tr h="198120">
                <a:tc grid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eatosi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1829450"/>
                  </a:ext>
                </a:extLst>
              </a:tr>
              <a:tr h="198120">
                <a:tc grid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iliary featur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0192428"/>
                  </a:ext>
                </a:extLst>
              </a:tr>
              <a:tr h="198120">
                <a:tc grid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lammatory infilt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0.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1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4480594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B252753-33AA-B10B-5F40-EC3D10A4CA8B}"/>
              </a:ext>
            </a:extLst>
          </p:cNvPr>
          <p:cNvSpPr txBox="1"/>
          <p:nvPr/>
        </p:nvSpPr>
        <p:spPr>
          <a:xfrm>
            <a:off x="1054100" y="7547518"/>
            <a:ext cx="4660900" cy="8937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3: histological features observed in 47 patients with CVID who underwent liver biopsy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87535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5C9C44B-2AAE-12BD-13B7-6931DC1BC8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8000621"/>
              </p:ext>
            </p:extLst>
          </p:nvPr>
        </p:nvGraphicFramePr>
        <p:xfrm>
          <a:off x="646455" y="358212"/>
          <a:ext cx="5795686" cy="833341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8885">
                  <a:extLst>
                    <a:ext uri="{9D8B030D-6E8A-4147-A177-3AD203B41FA5}">
                      <a16:colId xmlns:a16="http://schemas.microsoft.com/office/drawing/2014/main" val="3502380724"/>
                    </a:ext>
                  </a:extLst>
                </a:gridCol>
                <a:gridCol w="1219201">
                  <a:extLst>
                    <a:ext uri="{9D8B030D-6E8A-4147-A177-3AD203B41FA5}">
                      <a16:colId xmlns:a16="http://schemas.microsoft.com/office/drawing/2014/main" val="411829505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18718393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789155088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254454506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89322560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11775715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 err="1">
                          <a:effectLst/>
                        </a:rPr>
                        <a:t>Fibroscan</a:t>
                      </a:r>
                      <a:r>
                        <a:rPr lang="en-GB" sz="1100" u="none" strike="noStrike" dirty="0">
                          <a:effectLst/>
                        </a:rPr>
                        <a:t> performed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No fibrosca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4443441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%, (IQR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%, (IQR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262003416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Tota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5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0.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2459232603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Gender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Mal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7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3.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6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729966086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Femal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2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56.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391343448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ge (years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t CVID diagno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(22-41.5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(20-40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0.2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4244348961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Decades of diagno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60-’7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5.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1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654828912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80-’9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3.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4047055234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00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2.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1.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2174582761"/>
                  </a:ext>
                </a:extLst>
              </a:tr>
              <a:tr h="216000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Follow up (years)</a:t>
                      </a:r>
                    </a:p>
                  </a:txBody>
                  <a:tcPr marL="6136" marR="6136" marT="6136" marB="0"/>
                </a:tc>
                <a:tc h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(10-28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(13-27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2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1768641763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Lung disease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ny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7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0.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5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198792450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LD / GLILD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9.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1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171423288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Bronchiectasi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7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4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1610355782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Splenomegaly 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&gt;12cm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2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6.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0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33741127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plenectom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9.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3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991642989"/>
                  </a:ext>
                </a:extLst>
              </a:tr>
              <a:tr h="216000">
                <a:tc rowSpan="9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GI disease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2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8.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5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345068810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Chronic diarrhoea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8.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7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28300685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“enteropathy”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6.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5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475346200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IBD-lik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9.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7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89212293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Villous blunting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2.7 (n=22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8.6 (n=21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6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03970866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nfectiv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1.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7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58144332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    Noroviru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7.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9.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7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18395249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    Giardi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7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7.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1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62290329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    Othe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.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7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1319651356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Joint disea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2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3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34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92210268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rthriti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2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3.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8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405755514"/>
                  </a:ext>
                </a:extLst>
              </a:tr>
              <a:tr h="216000">
                <a:tc rowSpan="4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 err="1">
                          <a:effectLst/>
                        </a:rPr>
                        <a:t>Cytopaenia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7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7.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9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128017014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TP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7.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8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82486915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IH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3.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5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47461946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I neutropaeni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5.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4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665929364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Other autoimmunit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5.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9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99289555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Thyroid disea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7.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9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84620609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Othe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.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9.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0.7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1417287415"/>
                  </a:ext>
                </a:extLst>
              </a:tr>
              <a:tr h="2160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1100" b="1" u="none" strike="noStrike" dirty="0">
                          <a:effectLst/>
                        </a:rPr>
                        <a:t>Portal HTN (endoscopic, radiological or HVPG&gt;5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24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60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15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29.4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0.004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947375522"/>
                  </a:ext>
                </a:extLst>
              </a:tr>
              <a:tr h="216000">
                <a:tc rowSpan="4"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 investigations and assessment of PHTN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er Biopsy</a:t>
                      </a:r>
                      <a:endParaRPr lang="en-GB" b="1" dirty="0"/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674592484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doscopy</a:t>
                      </a:r>
                      <a:endParaRPr lang="en-GB" b="1" dirty="0"/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254031141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ology</a:t>
                      </a:r>
                      <a:endParaRPr lang="en-GB" b="0" dirty="0"/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399038570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VPG measurement</a:t>
                      </a:r>
                      <a:endParaRPr lang="en-GB" b="1" dirty="0"/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6136" marR="6136" marT="6136" marB="0"/>
                </a:tc>
                <a:extLst>
                  <a:ext uri="{0D108BD9-81ED-4DB2-BD59-A6C34878D82A}">
                    <a16:rowId xmlns:a16="http://schemas.microsoft.com/office/drawing/2014/main" val="4149436349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FADDCC0-1843-89FA-105F-72B8F70ADA0D}"/>
              </a:ext>
            </a:extLst>
          </p:cNvPr>
          <p:cNvSpPr txBox="1"/>
          <p:nvPr/>
        </p:nvSpPr>
        <p:spPr>
          <a:xfrm>
            <a:off x="646455" y="8907128"/>
            <a:ext cx="5862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table 4: Clinical characteristics of patients with liver disease who underwent Fibroscan compared to those who did not</a:t>
            </a:r>
            <a:endParaRPr lang="en-GB" sz="1400" dirty="0">
              <a:effectLst/>
              <a:latin typeface="Calibri 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11726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017D7AB-9AF2-5AE2-62A3-92F38AB00E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7599289"/>
              </p:ext>
            </p:extLst>
          </p:nvPr>
        </p:nvGraphicFramePr>
        <p:xfrm>
          <a:off x="713270" y="1437712"/>
          <a:ext cx="5795685" cy="6912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8885">
                  <a:extLst>
                    <a:ext uri="{9D8B030D-6E8A-4147-A177-3AD203B41FA5}">
                      <a16:colId xmlns:a16="http://schemas.microsoft.com/office/drawing/2014/main" val="3502380724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411829505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18718393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789155088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254454506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89322560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11775715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Endoscopy performed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No endoscop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4443441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%, (IQR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%, (IQR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262003416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Tota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459232603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Gender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Mal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2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.8</a:t>
                      </a:r>
                    </a:p>
                  </a:txBody>
                  <a:tcPr marL="9525" marR="9525" marT="9525" marB="0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729966086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Femal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.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2</a:t>
                      </a:r>
                    </a:p>
                  </a:txBody>
                  <a:tcPr marL="9525" marR="9525" marT="9525" marB="0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91343448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ge (years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t CVID diagno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0-41)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2-40)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4244348961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Decades of diagno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60-’7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</a:t>
                      </a:r>
                    </a:p>
                  </a:txBody>
                  <a:tcPr marL="9525" marR="9525" marT="9525" marB="0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654828912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80-’9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1</a:t>
                      </a:r>
                    </a:p>
                  </a:txBody>
                  <a:tcPr marL="9525" marR="9525" marT="9525" marB="0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4047055234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00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2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1</a:t>
                      </a:r>
                    </a:p>
                  </a:txBody>
                  <a:tcPr marL="9525" marR="9525" marT="9525" marB="0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174582761"/>
                  </a:ext>
                </a:extLst>
              </a:tr>
              <a:tr h="216000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Follow up (years)</a:t>
                      </a:r>
                    </a:p>
                  </a:txBody>
                  <a:tcPr marL="6136" marR="6136" marT="6136" marB="0"/>
                </a:tc>
                <a:tc h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4-27)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9-24)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768641763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Lung disease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ny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6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98792450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LD / GLILD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71423288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Bronchiectasi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610355782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Splenomegaly </a:t>
                      </a:r>
                    </a:p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&gt;12cm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33741127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plenectom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991642989"/>
                  </a:ext>
                </a:extLst>
              </a:tr>
              <a:tr h="216000">
                <a:tc rowSpan="8"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GI disease</a:t>
                      </a:r>
                    </a:p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</a:p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>
                          <a:effectLst/>
                        </a:rPr>
                        <a:t>An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.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345068810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>
                          <a:effectLst/>
                        </a:rPr>
                        <a:t>Chronic diarrhoea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28300685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>
                          <a:effectLst/>
                        </a:rPr>
                        <a:t>“enteropathy”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5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475346200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IBD-lik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89212293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nfectiv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58144332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   </a:t>
                      </a:r>
                      <a:r>
                        <a:rPr lang="en-GB" sz="1100" b="1" u="none" strike="noStrike" dirty="0">
                          <a:effectLst/>
                        </a:rPr>
                        <a:t>Noroviru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18395249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    Giardi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62290329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    Othe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319651356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Joint disea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92210268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rthriti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405755514"/>
                  </a:ext>
                </a:extLst>
              </a:tr>
              <a:tr h="216000">
                <a:tc rowSpan="4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 err="1">
                          <a:effectLst/>
                        </a:rPr>
                        <a:t>Cytopaenia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5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28017014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TP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5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82486915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IH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47461946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I neutropaeni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665929364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Other autoimmunit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3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99289555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Thyroid disea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84620609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Othe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7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141728741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75F4EF8-9479-5FE8-8EEF-3DF38F09141F}"/>
              </a:ext>
            </a:extLst>
          </p:cNvPr>
          <p:cNvSpPr txBox="1"/>
          <p:nvPr/>
        </p:nvSpPr>
        <p:spPr>
          <a:xfrm>
            <a:off x="646455" y="8349712"/>
            <a:ext cx="58625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table 5: Clinical characteristics of patients with liver disease who underwent upper gastrointestinal endoscopy compared to those who did not</a:t>
            </a:r>
            <a:endParaRPr lang="en-GB" sz="1400" dirty="0">
              <a:effectLst/>
              <a:latin typeface="Calibri 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73387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CBD79A6-4707-97B7-3922-37875DEBE2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2269230"/>
              </p:ext>
            </p:extLst>
          </p:nvPr>
        </p:nvGraphicFramePr>
        <p:xfrm>
          <a:off x="713270" y="1437712"/>
          <a:ext cx="5795685" cy="7128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8885">
                  <a:extLst>
                    <a:ext uri="{9D8B030D-6E8A-4147-A177-3AD203B41FA5}">
                      <a16:colId xmlns:a16="http://schemas.microsoft.com/office/drawing/2014/main" val="3502380724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411829505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18718393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789155088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254454506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89322560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11775715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HVPG measured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No HVPG measuremen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4443441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%, (IQR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%, (IQR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262003416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Tota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59232603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Gender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Mal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9</a:t>
                      </a:r>
                    </a:p>
                  </a:txBody>
                  <a:tcPr marL="9525" marR="9525" marT="9525" marB="0" anchor="b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2729966086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Femal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1</a:t>
                      </a:r>
                    </a:p>
                  </a:txBody>
                  <a:tcPr marL="9525" marR="9525" marT="9525" marB="0" anchor="b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1343448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ge (years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t CVID diagno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0.5-38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21-43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44348961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Decades of diagno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60-’7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7</a:t>
                      </a:r>
                    </a:p>
                  </a:txBody>
                  <a:tcPr marL="9525" marR="9525" marT="9525" marB="0" anchor="b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</a:t>
                      </a:r>
                    </a:p>
                  </a:txBody>
                  <a:tcPr marL="9525" marR="9525" marT="9525" marB="0"/>
                </a:tc>
                <a:extLst>
                  <a:ext uri="{0D108BD9-81ED-4DB2-BD59-A6C34878D82A}">
                    <a16:rowId xmlns:a16="http://schemas.microsoft.com/office/drawing/2014/main" val="3654828912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80-’9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7</a:t>
                      </a:r>
                    </a:p>
                  </a:txBody>
                  <a:tcPr marL="9525" marR="9525" marT="9525" marB="0" anchor="b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47055234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‘00-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.5</a:t>
                      </a:r>
                    </a:p>
                  </a:txBody>
                  <a:tcPr marL="9525" marR="9525" marT="9525" marB="0" anchor="b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74582761"/>
                  </a:ext>
                </a:extLst>
              </a:tr>
              <a:tr h="216000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Follow up (years)</a:t>
                      </a:r>
                    </a:p>
                  </a:txBody>
                  <a:tcPr marL="6136" marR="6136" marT="6136" marB="0"/>
                </a:tc>
                <a:tc h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4-25.5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10-27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68641763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Lung disease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Any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8792450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LD / GLILD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1423288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Bronchiectasi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10355782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Splenomegaly </a:t>
                      </a:r>
                    </a:p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</a:rPr>
                        <a:t>&gt;12cm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3741127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Splenectom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91642989"/>
                  </a:ext>
                </a:extLst>
              </a:tr>
              <a:tr h="216000">
                <a:tc rowSpan="9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GI disease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45068810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Chronic diarrhoea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8300685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“enteropathy”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75346200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IBD-lik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9212293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</a:t>
                      </a:r>
                      <a:r>
                        <a:rPr lang="en-GB" sz="1100" b="1" u="none" strike="noStrike" dirty="0">
                          <a:effectLst/>
                        </a:rPr>
                        <a:t>Villous blunting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1 (n=17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5(n26)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3970866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nfectiv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8144332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    Noroviru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8395249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    Giardi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2290329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    Othe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19651356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Joint disea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.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2210268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rthriti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05755514"/>
                  </a:ext>
                </a:extLst>
              </a:tr>
              <a:tr h="216000">
                <a:tc rowSpan="4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 err="1">
                          <a:effectLst/>
                        </a:rPr>
                        <a:t>Cytopaenia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8017014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ITP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2486915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IH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7461946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I neutropaeni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65929364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Other autoimmunit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An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9289555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Thyroid disea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620609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</a:rPr>
                        <a:t>Othe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1728741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B96AF9A-F9BC-1DF9-4517-588B5E646EA7}"/>
              </a:ext>
            </a:extLst>
          </p:cNvPr>
          <p:cNvSpPr txBox="1"/>
          <p:nvPr/>
        </p:nvSpPr>
        <p:spPr>
          <a:xfrm>
            <a:off x="646455" y="8565712"/>
            <a:ext cx="58625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table 6: Clinical characteristics of patients with liver disease who underwent hepatic venous pressure gradient measurement compared to those who did not</a:t>
            </a:r>
            <a:endParaRPr lang="en-GB" sz="1400" dirty="0">
              <a:effectLst/>
              <a:latin typeface="Calibri 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06696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4041254-8FDA-D0C4-338D-904BD73E42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1528376"/>
              </p:ext>
            </p:extLst>
          </p:nvPr>
        </p:nvGraphicFramePr>
        <p:xfrm>
          <a:off x="713270" y="1437712"/>
          <a:ext cx="5795685" cy="7128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8885">
                  <a:extLst>
                    <a:ext uri="{9D8B030D-6E8A-4147-A177-3AD203B41FA5}">
                      <a16:colId xmlns:a16="http://schemas.microsoft.com/office/drawing/2014/main" val="3502380724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val="4118295057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318718393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789155088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254454506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893225603"/>
                    </a:ext>
                  </a:extLst>
                </a:gridCol>
                <a:gridCol w="731520">
                  <a:extLst>
                    <a:ext uri="{9D8B030D-6E8A-4147-A177-3AD203B41FA5}">
                      <a16:colId xmlns:a16="http://schemas.microsoft.com/office/drawing/2014/main" val="1011775715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Liver Biops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No Liver biops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44434418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%, (IQR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%, (IQR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p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extLst>
                  <a:ext uri="{0D108BD9-81ED-4DB2-BD59-A6C34878D82A}">
                    <a16:rowId xmlns:a16="http://schemas.microsoft.com/office/drawing/2014/main" val="262003416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Total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0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0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 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59232603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Gender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Mal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4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5.5</a:t>
                      </a:r>
                    </a:p>
                  </a:txBody>
                  <a:tcPr marL="6350" marR="6350" marT="6350" marB="0" anchor="b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94</a:t>
                      </a: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val="2729966086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Femal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5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4.5</a:t>
                      </a:r>
                    </a:p>
                  </a:txBody>
                  <a:tcPr marL="6350" marR="6350" marT="6350" marB="0" anchor="b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343448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Age (years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At CVID diagno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(20-41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(21-41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7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244348961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Decades of diagno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‘60-’7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.3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3.6</a:t>
                      </a:r>
                    </a:p>
                  </a:txBody>
                  <a:tcPr marL="6350" marR="6350" marT="6350" marB="0" anchor="b"/>
                </a:tc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42</a:t>
                      </a:r>
                    </a:p>
                  </a:txBody>
                  <a:tcPr marL="6350" marR="6350" marT="6350" marB="0"/>
                </a:tc>
                <a:extLst>
                  <a:ext uri="{0D108BD9-81ED-4DB2-BD59-A6C34878D82A}">
                    <a16:rowId xmlns:a16="http://schemas.microsoft.com/office/drawing/2014/main" val="3654828912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‘80-’9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8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9.5</a:t>
                      </a:r>
                    </a:p>
                  </a:txBody>
                  <a:tcPr marL="6350" marR="6350" marT="6350" marB="0" anchor="b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47055234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‘00-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5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6.8</a:t>
                      </a:r>
                    </a:p>
                  </a:txBody>
                  <a:tcPr marL="6350" marR="6350" marT="6350" marB="0" anchor="b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4582761"/>
                  </a:ext>
                </a:extLst>
              </a:tr>
              <a:tr h="216000">
                <a:tc grid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Follow up (years)</a:t>
                      </a:r>
                      <a:endParaRPr lang="en-GB" sz="1100" u="none" strike="noStrike" dirty="0"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 h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(13-26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(10-28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4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768641763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 dirty="0">
                          <a:effectLst/>
                          <a:latin typeface="Calibri "/>
                        </a:rPr>
                        <a:t>Lung disease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 </a:t>
                      </a:r>
                    </a:p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Any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78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77.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8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8792450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>
                          <a:effectLst/>
                          <a:latin typeface="Calibri "/>
                        </a:rPr>
                        <a:t>ILD / GLIL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6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0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71423288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0" u="none" strike="noStrike">
                          <a:effectLst/>
                          <a:latin typeface="Calibri "/>
                        </a:rPr>
                        <a:t>Bronchiectasi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3.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70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5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10355782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>
                          <a:effectLst/>
                          <a:latin typeface="Calibri "/>
                        </a:rPr>
                        <a:t>Splenomegaly </a:t>
                      </a:r>
                    </a:p>
                    <a:p>
                      <a:pPr algn="l" rtl="0" fontAlgn="b"/>
                      <a:r>
                        <a:rPr lang="en-GB" sz="1100" b="1" u="none" strike="noStrike">
                          <a:effectLst/>
                          <a:latin typeface="Calibri "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b="1" u="none" strike="noStrike">
                          <a:effectLst/>
                          <a:latin typeface="Calibri "/>
                        </a:rPr>
                        <a:t>&gt;12cm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85.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1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&lt;0.00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3741127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Splenectomy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0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.5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2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991642989"/>
                  </a:ext>
                </a:extLst>
              </a:tr>
              <a:tr h="216000">
                <a:tc rowSpan="9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GI disease</a:t>
                      </a:r>
                    </a:p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 </a:t>
                      </a:r>
                    </a:p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>
                          <a:effectLst/>
                          <a:latin typeface="Calibri "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>
                          <a:effectLst/>
                          <a:latin typeface="Calibri "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>
                          <a:effectLst/>
                          <a:latin typeface="Calibri "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>
                          <a:effectLst/>
                          <a:latin typeface="Calibri "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>
                          <a:effectLst/>
                          <a:latin typeface="Calibri "/>
                        </a:rPr>
                        <a:t> </a:t>
                      </a:r>
                    </a:p>
                    <a:p>
                      <a:pPr algn="l" fontAlgn="t"/>
                      <a:r>
                        <a:rPr lang="en-GB" sz="1100" u="none" strike="noStrike">
                          <a:effectLst/>
                          <a:latin typeface="Calibri "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Any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8.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3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6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45068810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Chronic diarrhoea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7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6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9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8300685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“enteropathy”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7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75346200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 IBD-lik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0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.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7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89212293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 </a:t>
                      </a:r>
                      <a:r>
                        <a:rPr lang="en-GB" sz="1100" b="1" u="none" strike="noStrike">
                          <a:effectLst/>
                          <a:latin typeface="Calibri "/>
                        </a:rPr>
                        <a:t>Villous blunting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0 (n 25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.6 (n 18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0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970866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Infectiv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5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0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5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8144332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    Noroviru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2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.5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1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8395249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    Giardi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2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1.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8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22903298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pPr algn="l" fontAlgn="t"/>
                      <a:r>
                        <a:rPr lang="en-GB" sz="1100" u="none" strike="noStrike" dirty="0">
                          <a:effectLst/>
                        </a:rPr>
                        <a:t> 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    Othe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.2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9.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3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319651356"/>
                  </a:ext>
                </a:extLst>
              </a:tr>
              <a:tr h="216000">
                <a:tc rowSpan="2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Joint disea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An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9.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0.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2210268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Arthriti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2.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3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9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05755514"/>
                  </a:ext>
                </a:extLst>
              </a:tr>
              <a:tr h="216000">
                <a:tc rowSpan="4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Cytopaenia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Any</a:t>
                      </a:r>
                      <a:endParaRPr lang="en-GB" sz="1100" b="1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4.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9.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1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8017014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ITP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4.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7.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0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82486915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 dirty="0">
                          <a:effectLst/>
                          <a:latin typeface="Calibri "/>
                        </a:rPr>
                        <a:t>AIHA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4.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9.0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3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74619469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AI neutropaenia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0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.5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2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65929364"/>
                  </a:ext>
                </a:extLst>
              </a:tr>
              <a:tr h="216000">
                <a:tc rowSpan="3"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Other autoimmunit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Any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3.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6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92895557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Thyroid diseas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8.5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.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7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846206095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100" u="none" strike="noStrike">
                          <a:effectLst/>
                          <a:latin typeface="Calibri "/>
                        </a:rPr>
                        <a:t>Other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136" marR="6136" marT="613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10.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3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6.8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 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 "/>
                        </a:rPr>
                        <a:t>0.5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1728741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464D424-1527-F8D6-84C2-0A642E029755}"/>
              </a:ext>
            </a:extLst>
          </p:cNvPr>
          <p:cNvSpPr txBox="1"/>
          <p:nvPr/>
        </p:nvSpPr>
        <p:spPr>
          <a:xfrm>
            <a:off x="646455" y="8565712"/>
            <a:ext cx="5862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Supplementary table 7: Clinical characteristics of patients with liver disease who underwent liver biopsy compared to those who did not</a:t>
            </a:r>
            <a:endParaRPr lang="en-GB" sz="1400" dirty="0">
              <a:effectLst/>
              <a:latin typeface="Calibri 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753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69</Words>
  <Application>Microsoft Office PowerPoint</Application>
  <PresentationFormat>A4 Paper (210x297 mm)</PresentationFormat>
  <Paragraphs>1277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</vt:lpstr>
      <vt:lpstr>Calibri Light</vt:lpstr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Halliday</dc:creator>
  <cp:lastModifiedBy>Neil Halliday</cp:lastModifiedBy>
  <cp:revision>11</cp:revision>
  <dcterms:created xsi:type="dcterms:W3CDTF">2022-06-09T12:01:30Z</dcterms:created>
  <dcterms:modified xsi:type="dcterms:W3CDTF">2023-07-14T09:45:48Z</dcterms:modified>
</cp:coreProperties>
</file>